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  <p15:guide id="3" orient="horz" pos="5759">
          <p15:clr>
            <a:srgbClr val="A4A3A4"/>
          </p15:clr>
        </p15:guide>
        <p15:guide id="4" pos="431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770" autoAdjust="0"/>
    <p:restoredTop sz="94705" autoAdjust="0"/>
  </p:normalViewPr>
  <p:slideViewPr>
    <p:cSldViewPr>
      <p:cViewPr varScale="1">
        <p:scale>
          <a:sx n="65" d="100"/>
          <a:sy n="65" d="100"/>
        </p:scale>
        <p:origin x="-1560" y="-96"/>
      </p:cViewPr>
      <p:guideLst>
        <p:guide orient="horz" pos="2880"/>
        <p:guide orient="horz" pos="5759"/>
        <p:guide pos="2160"/>
        <p:guide pos="4319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Cfi\cfi$\ImmuneAnalysis\Junko\Neoantigen\OVA011%20summary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F:\IFN-g_022518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8.8149070651882794E-2"/>
          <c:y val="5.1400554097404502E-2"/>
          <c:w val="0.85009909475601297"/>
          <c:h val="0.74131926217556099"/>
        </c:manualLayout>
      </c:layout>
      <c:lineChart>
        <c:grouping val="standard"/>
        <c:varyColors val="0"/>
        <c:ser>
          <c:idx val="0"/>
          <c:order val="0"/>
          <c:tx>
            <c:strRef>
              <c:f>'[3]OVA11_TCR avidity_120617'!$B$13</c:f>
              <c:strCache>
                <c:ptCount val="1"/>
                <c:pt idx="0">
                  <c:v>Mut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diamond"/>
            <c:size val="8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3]OVA11_TCR avidity_120617'!$D$14:$D$21</c:f>
                <c:numCache>
                  <c:formatCode>General</c:formatCode>
                  <c:ptCount val="8"/>
                  <c:pt idx="0">
                    <c:v>1.674315780649914</c:v>
                  </c:pt>
                  <c:pt idx="1">
                    <c:v>2.5865034312755091</c:v>
                  </c:pt>
                  <c:pt idx="2">
                    <c:v>2.8219378684395831</c:v>
                  </c:pt>
                  <c:pt idx="3">
                    <c:v>1.8036999011291579</c:v>
                  </c:pt>
                  <c:pt idx="4">
                    <c:v>0.83266639978645196</c:v>
                  </c:pt>
                  <c:pt idx="5">
                    <c:v>0.556776436283002</c:v>
                  </c:pt>
                  <c:pt idx="6">
                    <c:v>1.0818656724997491</c:v>
                  </c:pt>
                  <c:pt idx="7">
                    <c:v>1.5981969006769161</c:v>
                  </c:pt>
                </c:numCache>
              </c:numRef>
            </c:plus>
            <c:minus>
              <c:numRef>
                <c:f>'[3]OVA11_TCR avidity_120617'!$D$14:$D$21</c:f>
                <c:numCache>
                  <c:formatCode>General</c:formatCode>
                  <c:ptCount val="8"/>
                  <c:pt idx="0">
                    <c:v>1.674315780649914</c:v>
                  </c:pt>
                  <c:pt idx="1">
                    <c:v>2.5865034312755091</c:v>
                  </c:pt>
                  <c:pt idx="2">
                    <c:v>2.8219378684395831</c:v>
                  </c:pt>
                  <c:pt idx="3">
                    <c:v>1.8036999011291579</c:v>
                  </c:pt>
                  <c:pt idx="4">
                    <c:v>0.83266639978645196</c:v>
                  </c:pt>
                  <c:pt idx="5">
                    <c:v>0.556776436283002</c:v>
                  </c:pt>
                  <c:pt idx="6">
                    <c:v>1.0818656724997491</c:v>
                  </c:pt>
                  <c:pt idx="7">
                    <c:v>1.5981969006769161</c:v>
                  </c:pt>
                </c:numCache>
              </c:numRef>
            </c:minus>
          </c:errBars>
          <c:cat>
            <c:numRef>
              <c:f>'[3]OVA11_TCR avidity_120617'!$A$14:$A$21</c:f>
              <c:numCache>
                <c:formatCode>General</c:formatCode>
                <c:ptCount val="8"/>
                <c:pt idx="0">
                  <c:v>10</c:v>
                </c:pt>
                <c:pt idx="1">
                  <c:v>1</c:v>
                </c:pt>
                <c:pt idx="2">
                  <c:v>0.1</c:v>
                </c:pt>
                <c:pt idx="3">
                  <c:v>0.01</c:v>
                </c:pt>
                <c:pt idx="4">
                  <c:v>1E-3</c:v>
                </c:pt>
                <c:pt idx="5">
                  <c:v>1E-4</c:v>
                </c:pt>
                <c:pt idx="6">
                  <c:v>1.0000000000000001E-5</c:v>
                </c:pt>
                <c:pt idx="7">
                  <c:v>0</c:v>
                </c:pt>
              </c:numCache>
            </c:numRef>
          </c:cat>
          <c:val>
            <c:numRef>
              <c:f>'[3]OVA11_TCR avidity_120617'!$B$14:$B$21</c:f>
              <c:numCache>
                <c:formatCode>General</c:formatCode>
                <c:ptCount val="8"/>
                <c:pt idx="0">
                  <c:v>58.333333333333343</c:v>
                </c:pt>
                <c:pt idx="1">
                  <c:v>71.3</c:v>
                </c:pt>
                <c:pt idx="2">
                  <c:v>70.8333333333333</c:v>
                </c:pt>
                <c:pt idx="3">
                  <c:v>59.733333333333327</c:v>
                </c:pt>
                <c:pt idx="4">
                  <c:v>30.53333333333331</c:v>
                </c:pt>
                <c:pt idx="5">
                  <c:v>11.6</c:v>
                </c:pt>
                <c:pt idx="6">
                  <c:v>8.0333333333333332</c:v>
                </c:pt>
                <c:pt idx="7">
                  <c:v>7.733333333333336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6A31-C345-9C7F-8D334B7B69DB}"/>
            </c:ext>
          </c:extLst>
        </c:ser>
        <c:ser>
          <c:idx val="1"/>
          <c:order val="1"/>
          <c:tx>
            <c:strRef>
              <c:f>'[3]OVA11_TCR avidity_120617'!$C$13</c:f>
              <c:strCache>
                <c:ptCount val="1"/>
                <c:pt idx="0">
                  <c:v>WT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triangle"/>
            <c:size val="8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3]OVA11_TCR avidity_120617'!$E$14:$E$21</c:f>
                <c:numCache>
                  <c:formatCode>General</c:formatCode>
                  <c:ptCount val="8"/>
                  <c:pt idx="0">
                    <c:v>1.0614298532325781</c:v>
                  </c:pt>
                  <c:pt idx="1">
                    <c:v>1.311487704860405</c:v>
                  </c:pt>
                  <c:pt idx="2">
                    <c:v>1.3328665849714041</c:v>
                  </c:pt>
                  <c:pt idx="3">
                    <c:v>1.7001568555087361</c:v>
                  </c:pt>
                  <c:pt idx="4">
                    <c:v>1.412338486340998</c:v>
                  </c:pt>
                  <c:pt idx="5">
                    <c:v>1.3817380359532641</c:v>
                  </c:pt>
                  <c:pt idx="6">
                    <c:v>1.31804147633272</c:v>
                  </c:pt>
                  <c:pt idx="7">
                    <c:v>1.5981969006769161</c:v>
                  </c:pt>
                </c:numCache>
              </c:numRef>
            </c:plus>
            <c:minus>
              <c:numRef>
                <c:f>'[3]OVA11_TCR avidity_120617'!$E$14:$E$21</c:f>
                <c:numCache>
                  <c:formatCode>General</c:formatCode>
                  <c:ptCount val="8"/>
                  <c:pt idx="0">
                    <c:v>1.0614298532325781</c:v>
                  </c:pt>
                  <c:pt idx="1">
                    <c:v>1.311487704860405</c:v>
                  </c:pt>
                  <c:pt idx="2">
                    <c:v>1.3328665849714041</c:v>
                  </c:pt>
                  <c:pt idx="3">
                    <c:v>1.7001568555087361</c:v>
                  </c:pt>
                  <c:pt idx="4">
                    <c:v>1.412338486340998</c:v>
                  </c:pt>
                  <c:pt idx="5">
                    <c:v>1.3817380359532641</c:v>
                  </c:pt>
                  <c:pt idx="6">
                    <c:v>1.31804147633272</c:v>
                  </c:pt>
                  <c:pt idx="7">
                    <c:v>1.5981969006769161</c:v>
                  </c:pt>
                </c:numCache>
              </c:numRef>
            </c:minus>
          </c:errBars>
          <c:cat>
            <c:numRef>
              <c:f>'[3]OVA11_TCR avidity_120617'!$A$14:$A$21</c:f>
              <c:numCache>
                <c:formatCode>General</c:formatCode>
                <c:ptCount val="8"/>
                <c:pt idx="0">
                  <c:v>10</c:v>
                </c:pt>
                <c:pt idx="1">
                  <c:v>1</c:v>
                </c:pt>
                <c:pt idx="2">
                  <c:v>0.1</c:v>
                </c:pt>
                <c:pt idx="3">
                  <c:v>0.01</c:v>
                </c:pt>
                <c:pt idx="4">
                  <c:v>1E-3</c:v>
                </c:pt>
                <c:pt idx="5">
                  <c:v>1E-4</c:v>
                </c:pt>
                <c:pt idx="6">
                  <c:v>1.0000000000000001E-5</c:v>
                </c:pt>
                <c:pt idx="7">
                  <c:v>0</c:v>
                </c:pt>
              </c:numCache>
            </c:numRef>
          </c:cat>
          <c:val>
            <c:numRef>
              <c:f>'[3]OVA11_TCR avidity_120617'!$C$14:$C$21</c:f>
              <c:numCache>
                <c:formatCode>General</c:formatCode>
                <c:ptCount val="8"/>
                <c:pt idx="0">
                  <c:v>10.84333333333333</c:v>
                </c:pt>
                <c:pt idx="1">
                  <c:v>7.43</c:v>
                </c:pt>
                <c:pt idx="2">
                  <c:v>7.0533333333333337</c:v>
                </c:pt>
                <c:pt idx="3">
                  <c:v>7.5966666666666667</c:v>
                </c:pt>
                <c:pt idx="4">
                  <c:v>7.7800000000000011</c:v>
                </c:pt>
                <c:pt idx="5">
                  <c:v>7.44</c:v>
                </c:pt>
                <c:pt idx="6">
                  <c:v>7.5266666666666664</c:v>
                </c:pt>
                <c:pt idx="7">
                  <c:v>7.733333333333336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6A31-C345-9C7F-8D334B7B69D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50094208"/>
        <c:axId val="150095744"/>
      </c:lineChart>
      <c:catAx>
        <c:axId val="1500942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ln w="12700">
            <a:solidFill>
              <a:schemeClr val="tx1"/>
            </a:solidFill>
          </a:ln>
        </c:spPr>
        <c:crossAx val="150095744"/>
        <c:crosses val="autoZero"/>
        <c:auto val="1"/>
        <c:lblAlgn val="ctr"/>
        <c:lblOffset val="100"/>
        <c:noMultiLvlLbl val="0"/>
      </c:catAx>
      <c:valAx>
        <c:axId val="150095744"/>
        <c:scaling>
          <c:orientation val="minMax"/>
          <c:max val="8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150094208"/>
        <c:crosses val="autoZero"/>
        <c:crossBetween val="between"/>
        <c:majorUnit val="20"/>
      </c:valAx>
    </c:plotArea>
    <c:legend>
      <c:legendPos val="r"/>
      <c:layout>
        <c:manualLayout>
          <c:xMode val="edge"/>
          <c:yMode val="edge"/>
          <c:x val="0.69712473897387295"/>
          <c:y val="6.4430956547098295E-2"/>
          <c:w val="0.24799733160242399"/>
          <c:h val="0.135026975794692"/>
        </c:manualLayout>
      </c:layout>
      <c:overlay val="0"/>
      <c:spPr>
        <a:ln>
          <a:solidFill>
            <a:schemeClr val="tx1"/>
          </a:solidFill>
        </a:ln>
      </c:spPr>
    </c:legend>
    <c:plotVisOnly val="1"/>
    <c:dispBlanksAs val="gap"/>
    <c:showDLblsOverMax val="0"/>
  </c:chart>
  <c:txPr>
    <a:bodyPr/>
    <a:lstStyle/>
    <a:p>
      <a:pPr>
        <a:defRPr b="1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6770435453544"/>
          <c:y val="4.83769920916748E-2"/>
          <c:w val="0.72386420835566001"/>
          <c:h val="0.8424654761292089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Plate 1 - Sheet1'!$M$105</c:f>
              <c:strCache>
                <c:ptCount val="1"/>
                <c:pt idx="0">
                  <c:v>T cell alone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rgbClr val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late 1 - Sheet1'!$P$105:$Q$105</c:f>
                <c:numCache>
                  <c:formatCode>General</c:formatCode>
                  <c:ptCount val="2"/>
                  <c:pt idx="1">
                    <c:v>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Plate 1 - Sheet1'!$N$104:$O$104</c:f>
              <c:strCache>
                <c:ptCount val="2"/>
                <c:pt idx="0">
                  <c:v>(-)</c:v>
                </c:pt>
                <c:pt idx="1">
                  <c:v>Vb13.6+</c:v>
                </c:pt>
              </c:strCache>
            </c:strRef>
          </c:cat>
          <c:val>
            <c:numRef>
              <c:f>'Plate 1 - Sheet1'!$N$105:$O$105</c:f>
              <c:numCache>
                <c:formatCode>General</c:formatCode>
                <c:ptCount val="2"/>
                <c:pt idx="1">
                  <c:v>8.841200469999998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11F2-CC48-B3F0-38C0B2F4CF82}"/>
            </c:ext>
          </c:extLst>
        </c:ser>
        <c:ser>
          <c:idx val="1"/>
          <c:order val="1"/>
          <c:tx>
            <c:strRef>
              <c:f>'Plate 1 - Sheet1'!$M$106</c:f>
              <c:strCache>
                <c:ptCount val="1"/>
                <c:pt idx="0">
                  <c:v>+PBMC</c:v>
                </c:pt>
              </c:strCache>
            </c:strRef>
          </c:tx>
          <c:spPr>
            <a:pattFill prst="dkUpDiag">
              <a:fgClr>
                <a:schemeClr val="tx1"/>
              </a:fgClr>
              <a:bgClr>
                <a:schemeClr val="bg1"/>
              </a:bgClr>
            </a:pattFill>
            <a:ln w="12700">
              <a:solidFill>
                <a:srgbClr val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late 1 - Sheet1'!$P$106:$Q$106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3.23162526200000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Plate 1 - Sheet1'!$N$104:$O$104</c:f>
              <c:strCache>
                <c:ptCount val="2"/>
                <c:pt idx="0">
                  <c:v>(-)</c:v>
                </c:pt>
                <c:pt idx="1">
                  <c:v>Vb13.6+</c:v>
                </c:pt>
              </c:strCache>
            </c:strRef>
          </c:cat>
          <c:val>
            <c:numRef>
              <c:f>'Plate 1 - Sheet1'!$N$106:$O$106</c:f>
              <c:numCache>
                <c:formatCode>General</c:formatCode>
                <c:ptCount val="2"/>
                <c:pt idx="0">
                  <c:v>0</c:v>
                </c:pt>
                <c:pt idx="1">
                  <c:v>4.969131658315949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11F2-CC48-B3F0-38C0B2F4CF82}"/>
            </c:ext>
          </c:extLst>
        </c:ser>
        <c:ser>
          <c:idx val="2"/>
          <c:order val="2"/>
          <c:tx>
            <c:strRef>
              <c:f>'Plate 1 - Sheet1'!$M$107</c:f>
              <c:strCache>
                <c:ptCount val="1"/>
                <c:pt idx="0">
                  <c:v>+AMC</c:v>
                </c:pt>
              </c:strCache>
            </c:strRef>
          </c:tx>
          <c:spPr>
            <a:pattFill prst="pct80">
              <a:fgClr>
                <a:schemeClr val="tx1"/>
              </a:fgClr>
              <a:bgClr>
                <a:schemeClr val="bg1"/>
              </a:bgClr>
            </a:pattFill>
            <a:ln w="12700">
              <a:solidFill>
                <a:srgbClr val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late 1 - Sheet1'!$P$107:$Q$107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53.9052315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Plate 1 - Sheet1'!$N$104:$O$104</c:f>
              <c:strCache>
                <c:ptCount val="2"/>
                <c:pt idx="0">
                  <c:v>(-)</c:v>
                </c:pt>
                <c:pt idx="1">
                  <c:v>Vb13.6+</c:v>
                </c:pt>
              </c:strCache>
            </c:strRef>
          </c:cat>
          <c:val>
            <c:numRef>
              <c:f>'Plate 1 - Sheet1'!$N$107:$O$107</c:f>
              <c:numCache>
                <c:formatCode>General</c:formatCode>
                <c:ptCount val="2"/>
                <c:pt idx="0">
                  <c:v>0</c:v>
                </c:pt>
                <c:pt idx="1">
                  <c:v>131.1730821743531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11F2-CC48-B3F0-38C0B2F4CF8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9243392"/>
        <c:axId val="149244928"/>
      </c:barChart>
      <c:catAx>
        <c:axId val="14924339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spPr>
          <a:ln w="12700">
            <a:solidFill>
              <a:srgbClr val="000000"/>
            </a:solidFill>
          </a:ln>
        </c:spPr>
        <c:crossAx val="149244928"/>
        <c:crosses val="autoZero"/>
        <c:auto val="1"/>
        <c:lblAlgn val="ctr"/>
        <c:lblOffset val="100"/>
        <c:noMultiLvlLbl val="0"/>
      </c:catAx>
      <c:valAx>
        <c:axId val="1492449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rgbClr val="000000"/>
            </a:solidFill>
          </a:ln>
        </c:spPr>
        <c:crossAx val="149243392"/>
        <c:crosses val="autoZero"/>
        <c:crossBetween val="between"/>
        <c:majorUnit val="50"/>
      </c:valAx>
    </c:plotArea>
    <c:legend>
      <c:legendPos val="r"/>
      <c:layout>
        <c:manualLayout>
          <c:xMode val="edge"/>
          <c:yMode val="edge"/>
          <c:x val="0.16795269711253699"/>
          <c:y val="5.9370814062223602E-2"/>
          <c:w val="0.38283823463000299"/>
          <c:h val="0.23637795275590501"/>
        </c:manualLayout>
      </c:layout>
      <c:overlay val="0"/>
      <c:spPr>
        <a:ln w="12700">
          <a:solidFill>
            <a:schemeClr val="tx1"/>
          </a:solidFill>
        </a:ln>
      </c:spPr>
    </c:legend>
    <c:plotVisOnly val="1"/>
    <c:dispBlanksAs val="gap"/>
    <c:showDLblsOverMax val="0"/>
  </c:chart>
  <c:txPr>
    <a:bodyPr/>
    <a:lstStyle/>
    <a:p>
      <a:pPr>
        <a:defRPr b="1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E707A8CC-A5A6-4894-9D87-EA98E8DF8647}" type="datetimeFigureOut">
              <a:rPr lang="en-US" smtClean="0"/>
              <a:t>5/21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A2CA58BC-4236-49E4-A71F-0C52C25D4C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40217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6722B-2FE8-41D5-83B1-531A5ED851E7}" type="datetimeFigureOut">
              <a:rPr lang="en-US" smtClean="0"/>
              <a:t>5/2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142E1-0E57-4B8D-A5C2-7D021643B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01030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6722B-2FE8-41D5-83B1-531A5ED851E7}" type="datetimeFigureOut">
              <a:rPr lang="en-US" smtClean="0"/>
              <a:t>5/2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142E1-0E57-4B8D-A5C2-7D021643B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21495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6722B-2FE8-41D5-83B1-531A5ED851E7}" type="datetimeFigureOut">
              <a:rPr lang="en-US" smtClean="0"/>
              <a:t>5/2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142E1-0E57-4B8D-A5C2-7D021643B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75514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6722B-2FE8-41D5-83B1-531A5ED851E7}" type="datetimeFigureOut">
              <a:rPr lang="en-US" smtClean="0"/>
              <a:t>5/2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142E1-0E57-4B8D-A5C2-7D021643B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81815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6722B-2FE8-41D5-83B1-531A5ED851E7}" type="datetimeFigureOut">
              <a:rPr lang="en-US" smtClean="0"/>
              <a:t>5/2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142E1-0E57-4B8D-A5C2-7D021643B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36014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6722B-2FE8-41D5-83B1-531A5ED851E7}" type="datetimeFigureOut">
              <a:rPr lang="en-US" smtClean="0"/>
              <a:t>5/2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142E1-0E57-4B8D-A5C2-7D021643B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17224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6722B-2FE8-41D5-83B1-531A5ED851E7}" type="datetimeFigureOut">
              <a:rPr lang="en-US" smtClean="0"/>
              <a:t>5/21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142E1-0E57-4B8D-A5C2-7D021643B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6638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6722B-2FE8-41D5-83B1-531A5ED851E7}" type="datetimeFigureOut">
              <a:rPr lang="en-US" smtClean="0"/>
              <a:t>5/21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142E1-0E57-4B8D-A5C2-7D021643B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6314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6722B-2FE8-41D5-83B1-531A5ED851E7}" type="datetimeFigureOut">
              <a:rPr lang="en-US" smtClean="0"/>
              <a:t>5/21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142E1-0E57-4B8D-A5C2-7D021643B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20342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6722B-2FE8-41D5-83B1-531A5ED851E7}" type="datetimeFigureOut">
              <a:rPr lang="en-US" smtClean="0"/>
              <a:t>5/2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142E1-0E57-4B8D-A5C2-7D021643B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33610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6722B-2FE8-41D5-83B1-531A5ED851E7}" type="datetimeFigureOut">
              <a:rPr lang="en-US" smtClean="0"/>
              <a:t>5/2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142E1-0E57-4B8D-A5C2-7D021643B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9258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86722B-2FE8-41D5-83B1-531A5ED851E7}" type="datetimeFigureOut">
              <a:rPr lang="en-US" smtClean="0"/>
              <a:t>5/2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E142E1-0E57-4B8D-A5C2-7D021643B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86139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4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2.xml"/><Relationship Id="rId5" Type="http://schemas.openxmlformats.org/officeDocument/2006/relationships/image" Target="../media/image3.emf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 rot="16200000">
            <a:off x="1123869" y="5758389"/>
            <a:ext cx="11063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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g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/ml)</a:t>
            </a: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2"/>
          <a:srcRect l="10277" t="6734" b="10470"/>
          <a:stretch/>
        </p:blipFill>
        <p:spPr>
          <a:xfrm>
            <a:off x="713516" y="1431537"/>
            <a:ext cx="1073027" cy="1033351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3"/>
          <a:srcRect l="10277" t="6734" b="10470"/>
          <a:stretch/>
        </p:blipFill>
        <p:spPr>
          <a:xfrm>
            <a:off x="1898774" y="1411243"/>
            <a:ext cx="1073027" cy="1033351"/>
          </a:xfrm>
          <a:prstGeom prst="rect">
            <a:avLst/>
          </a:prstGeom>
        </p:spPr>
      </p:pic>
      <p:sp>
        <p:nvSpPr>
          <p:cNvPr id="29" name="TextBox 28"/>
          <p:cNvSpPr txBox="1"/>
          <p:nvPr/>
        </p:nvSpPr>
        <p:spPr>
          <a:xfrm>
            <a:off x="95420" y="43934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8</a:t>
            </a:r>
          </a:p>
        </p:txBody>
      </p:sp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57697965"/>
              </p:ext>
            </p:extLst>
          </p:nvPr>
        </p:nvGraphicFramePr>
        <p:xfrm>
          <a:off x="3752031" y="1390165"/>
          <a:ext cx="2554342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5"/>
          <a:srcRect l="10835" t="5166" b="10661"/>
          <a:stretch/>
        </p:blipFill>
        <p:spPr>
          <a:xfrm>
            <a:off x="2117554" y="3000455"/>
            <a:ext cx="1082846" cy="1066799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3367363" y="4690735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cxnSp>
        <p:nvCxnSpPr>
          <p:cNvPr id="13" name="Straight Connector 12"/>
          <p:cNvCxnSpPr/>
          <p:nvPr/>
        </p:nvCxnSpPr>
        <p:spPr>
          <a:xfrm>
            <a:off x="3413967" y="4919335"/>
            <a:ext cx="18122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3594600" y="4921522"/>
            <a:ext cx="0" cy="8311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3413371" y="4921522"/>
            <a:ext cx="0" cy="8311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/>
          <p:cNvCxnSpPr/>
          <p:nvPr/>
        </p:nvCxnSpPr>
        <p:spPr>
          <a:xfrm>
            <a:off x="574083" y="2575043"/>
            <a:ext cx="277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41"/>
          <p:cNvCxnSpPr/>
          <p:nvPr/>
        </p:nvCxnSpPr>
        <p:spPr>
          <a:xfrm rot="16200000">
            <a:off x="435583" y="2436543"/>
            <a:ext cx="277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/>
          <p:cNvSpPr txBox="1"/>
          <p:nvPr/>
        </p:nvSpPr>
        <p:spPr>
          <a:xfrm>
            <a:off x="787415" y="2453199"/>
            <a:ext cx="6912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GM-CSF</a:t>
            </a:r>
            <a:endParaRPr lang="en-US" sz="10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 rot="16200000">
            <a:off x="330267" y="1987633"/>
            <a:ext cx="4876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</a:t>
            </a:r>
            <a:endParaRPr lang="en-US" sz="10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806208" y="1175420"/>
            <a:ext cx="8931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JAK1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Mut</a:t>
            </a:r>
            <a:endParaRPr lang="en-US" sz="12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2002684" y="1175420"/>
            <a:ext cx="8595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JAK1 WT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2341100" y="4039543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l-GR" sz="1000" b="1" dirty="0">
                <a:latin typeface="Arial"/>
                <a:cs typeface="Arial"/>
                <a:sym typeface="Symbol"/>
              </a:rPr>
              <a:t>β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.6</a:t>
            </a:r>
            <a:endParaRPr lang="en-US" sz="10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 rot="18900000">
            <a:off x="3971907" y="3633728"/>
            <a:ext cx="3738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50" name="TextBox 49"/>
          <p:cNvSpPr txBox="1"/>
          <p:nvPr/>
        </p:nvSpPr>
        <p:spPr>
          <a:xfrm rot="18900000">
            <a:off x="4182552" y="3633728"/>
            <a:ext cx="3738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51" name="TextBox 50"/>
          <p:cNvSpPr txBox="1"/>
          <p:nvPr/>
        </p:nvSpPr>
        <p:spPr>
          <a:xfrm rot="18900000">
            <a:off x="4393195" y="3643929"/>
            <a:ext cx="4026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</a:p>
        </p:txBody>
      </p:sp>
      <p:sp>
        <p:nvSpPr>
          <p:cNvPr id="52" name="TextBox 51"/>
          <p:cNvSpPr txBox="1"/>
          <p:nvPr/>
        </p:nvSpPr>
        <p:spPr>
          <a:xfrm rot="18900000">
            <a:off x="4632693" y="3643929"/>
            <a:ext cx="4026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</a:p>
        </p:txBody>
      </p:sp>
      <p:sp>
        <p:nvSpPr>
          <p:cNvPr id="53" name="TextBox 52"/>
          <p:cNvSpPr txBox="1"/>
          <p:nvPr/>
        </p:nvSpPr>
        <p:spPr>
          <a:xfrm rot="18900000">
            <a:off x="5111689" y="3643929"/>
            <a:ext cx="4026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4</a:t>
            </a:r>
          </a:p>
        </p:txBody>
      </p:sp>
      <p:sp>
        <p:nvSpPr>
          <p:cNvPr id="54" name="TextBox 53"/>
          <p:cNvSpPr txBox="1"/>
          <p:nvPr/>
        </p:nvSpPr>
        <p:spPr>
          <a:xfrm rot="18900000">
            <a:off x="4872191" y="3643929"/>
            <a:ext cx="4026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3</a:t>
            </a:r>
          </a:p>
        </p:txBody>
      </p:sp>
      <p:sp>
        <p:nvSpPr>
          <p:cNvPr id="55" name="TextBox 54"/>
          <p:cNvSpPr txBox="1"/>
          <p:nvPr/>
        </p:nvSpPr>
        <p:spPr>
          <a:xfrm rot="18900000">
            <a:off x="5351187" y="3643929"/>
            <a:ext cx="4026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5</a:t>
            </a:r>
          </a:p>
        </p:txBody>
      </p:sp>
      <p:sp>
        <p:nvSpPr>
          <p:cNvPr id="56" name="TextBox 55"/>
          <p:cNvSpPr txBox="1"/>
          <p:nvPr/>
        </p:nvSpPr>
        <p:spPr>
          <a:xfrm rot="18900000">
            <a:off x="5590683" y="3643929"/>
            <a:ext cx="4026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6</a:t>
            </a:r>
          </a:p>
        </p:txBody>
      </p:sp>
      <p:sp>
        <p:nvSpPr>
          <p:cNvPr id="57" name="TextBox 56"/>
          <p:cNvSpPr txBox="1"/>
          <p:nvPr/>
        </p:nvSpPr>
        <p:spPr>
          <a:xfrm rot="18900000">
            <a:off x="5943523" y="359178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0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 rot="16200000">
            <a:off x="2907707" y="2423893"/>
            <a:ext cx="13195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%IFN-</a:t>
            </a:r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sz="12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3.6</a:t>
            </a:r>
            <a:r>
              <a:rPr lang="en-US" sz="12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4400811" y="3857959"/>
            <a:ext cx="15760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eptide conc.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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  <a:endParaRPr lang="en-US" sz="12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152400" y="94681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3216125" y="94681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1414046" y="4477049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aphicFrame>
        <p:nvGraphicFramePr>
          <p:cNvPr id="79" name="Chart 7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08234120"/>
              </p:ext>
            </p:extLst>
          </p:nvPr>
        </p:nvGraphicFramePr>
        <p:xfrm>
          <a:off x="1834009" y="4843135"/>
          <a:ext cx="2280791" cy="22157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80" name="TextBox 79"/>
          <p:cNvSpPr txBox="1"/>
          <p:nvPr/>
        </p:nvSpPr>
        <p:spPr>
          <a:xfrm>
            <a:off x="3082855" y="6840379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3.6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2454575" y="6840379"/>
            <a:ext cx="3465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000" b="1" dirty="0">
                <a:latin typeface="Arial"/>
                <a:cs typeface="Arial"/>
              </a:rPr>
              <a:t>−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0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152400" y="271108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84" name="Picture 83"/>
          <p:cNvPicPr>
            <a:picLocks noChangeAspect="1"/>
          </p:cNvPicPr>
          <p:nvPr/>
        </p:nvPicPr>
        <p:blipFill rotWithShape="1">
          <a:blip r:embed="rId7"/>
          <a:srcRect l="10518" t="5242" b="10433"/>
          <a:stretch/>
        </p:blipFill>
        <p:spPr>
          <a:xfrm>
            <a:off x="685800" y="3000455"/>
            <a:ext cx="1091550" cy="1073497"/>
          </a:xfrm>
          <a:prstGeom prst="rect">
            <a:avLst/>
          </a:prstGeom>
        </p:spPr>
      </p:pic>
      <p:cxnSp>
        <p:nvCxnSpPr>
          <p:cNvPr id="85" name="Straight Arrow Connector 84"/>
          <p:cNvCxnSpPr/>
          <p:nvPr/>
        </p:nvCxnSpPr>
        <p:spPr>
          <a:xfrm>
            <a:off x="566454" y="4161389"/>
            <a:ext cx="277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Arrow Connector 85"/>
          <p:cNvCxnSpPr/>
          <p:nvPr/>
        </p:nvCxnSpPr>
        <p:spPr>
          <a:xfrm rot="16200000">
            <a:off x="427955" y="4022889"/>
            <a:ext cx="277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TextBox 86"/>
          <p:cNvSpPr txBox="1"/>
          <p:nvPr/>
        </p:nvSpPr>
        <p:spPr>
          <a:xfrm>
            <a:off x="779786" y="4053399"/>
            <a:ext cx="4491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CR</a:t>
            </a:r>
            <a:endParaRPr lang="en-US" sz="10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 rot="16200000">
            <a:off x="355730" y="3601688"/>
            <a:ext cx="4491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CR</a:t>
            </a:r>
            <a:endParaRPr lang="en-US" sz="10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1262220" y="3125142"/>
            <a:ext cx="5180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l-GR" sz="800" b="1" dirty="0">
                <a:latin typeface="Arial"/>
                <a:cs typeface="Arial"/>
              </a:rPr>
              <a:t>β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3.6</a:t>
            </a:r>
            <a:endParaRPr lang="en-US" sz="8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713511" y="3125142"/>
            <a:ext cx="5180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l-GR" sz="800" b="1" dirty="0">
                <a:latin typeface="Arial"/>
                <a:cs typeface="Arial"/>
              </a:rPr>
              <a:t>β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3.1</a:t>
            </a:r>
            <a:endParaRPr lang="en-US" sz="8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1406490" y="3672803"/>
            <a:ext cx="3738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l-GR" sz="800" b="1" dirty="0">
                <a:latin typeface="Arial"/>
                <a:cs typeface="Arial"/>
              </a:rPr>
              <a:t>β</a:t>
            </a:r>
            <a:r>
              <a:rPr lang="en-US" sz="800" b="1" dirty="0">
                <a:latin typeface="Arial"/>
                <a:cs typeface="Arial"/>
              </a:rPr>
              <a:t>8</a:t>
            </a:r>
            <a:endParaRPr lang="en-US" sz="8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1752600" y="271108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620844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636</TotalTime>
  <Words>64</Words>
  <Application>Microsoft Office PowerPoint</Application>
  <PresentationFormat>On-screen Show (4:3)</PresentationFormat>
  <Paragraphs>3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Roswell Park Cancer Institut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suzaki, Junko</dc:creator>
  <cp:lastModifiedBy>Amit Lugade</cp:lastModifiedBy>
  <cp:revision>86</cp:revision>
  <cp:lastPrinted>2018-06-28T15:19:03Z</cp:lastPrinted>
  <dcterms:created xsi:type="dcterms:W3CDTF">2018-02-07T19:36:58Z</dcterms:created>
  <dcterms:modified xsi:type="dcterms:W3CDTF">2019-05-21T20:52:56Z</dcterms:modified>
</cp:coreProperties>
</file>